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305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3FEFF"/>
    <a:srgbClr val="FF7E79"/>
    <a:srgbClr val="02FF00"/>
    <a:srgbClr val="FFF2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048"/>
    <p:restoredTop sz="97654"/>
  </p:normalViewPr>
  <p:slideViewPr>
    <p:cSldViewPr snapToGrid="0">
      <p:cViewPr varScale="1">
        <p:scale>
          <a:sx n="88" d="100"/>
          <a:sy n="88" d="100"/>
        </p:scale>
        <p:origin x="269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ACF953-C57F-EB4A-A397-C2E5F56A31AE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D4FC50-55FD-4845-9ADA-7EE4F3BC54B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463961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D4FC50-55FD-4845-9ADA-7EE4F3BC54B8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222912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20812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13822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140025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965086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55065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13799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360132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438097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44455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337904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16169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5D05DA-305C-1746-B8FF-94967069F73F}" type="datetimeFigureOut">
              <a:rPr lang="en-US" smtClean="0"/>
              <a:t>2/20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E23D9A-4BD8-894C-9582-734AD5BC2790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01614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tiff"/><Relationship Id="rId4" Type="http://schemas.openxmlformats.org/officeDocument/2006/relationships/image" Target="../media/image2.jpeg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Group 35">
            <a:extLst>
              <a:ext uri="{FF2B5EF4-FFF2-40B4-BE49-F238E27FC236}">
                <a16:creationId xmlns:a16="http://schemas.microsoft.com/office/drawing/2014/main" id="{8ECE966A-909C-BD22-F24A-5412BB638D97}"/>
              </a:ext>
            </a:extLst>
          </p:cNvPr>
          <p:cNvGrpSpPr/>
          <p:nvPr/>
        </p:nvGrpSpPr>
        <p:grpSpPr>
          <a:xfrm>
            <a:off x="206204" y="473664"/>
            <a:ext cx="5138730" cy="1261123"/>
            <a:chOff x="460445" y="1342049"/>
            <a:chExt cx="5138730" cy="1261123"/>
          </a:xfrm>
        </p:grpSpPr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0F43F01E-4B52-56D2-68F1-96F099916FD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375019" y="1744121"/>
              <a:ext cx="4224156" cy="498192"/>
            </a:xfrm>
            <a:prstGeom prst="rect">
              <a:avLst/>
            </a:prstGeom>
          </p:spPr>
        </p:pic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085D88C3-A6F4-67DD-0D3B-164B8C9EE688}"/>
                </a:ext>
              </a:extLst>
            </p:cNvPr>
            <p:cNvSpPr txBox="1"/>
            <p:nvPr/>
          </p:nvSpPr>
          <p:spPr>
            <a:xfrm>
              <a:off x="763624" y="1840116"/>
              <a:ext cx="12815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mig-15</a:t>
              </a:r>
            </a:p>
          </p:txBody>
        </p: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DC1A4E4F-108F-08AA-3A39-0CECDD016E64}"/>
                </a:ext>
              </a:extLst>
            </p:cNvPr>
            <p:cNvSpPr/>
            <p:nvPr/>
          </p:nvSpPr>
          <p:spPr>
            <a:xfrm>
              <a:off x="696141" y="1518637"/>
              <a:ext cx="1869435" cy="34691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552326DF-3753-3CBE-4116-C40FD34E203A}"/>
                </a:ext>
              </a:extLst>
            </p:cNvPr>
            <p:cNvSpPr/>
            <p:nvPr/>
          </p:nvSpPr>
          <p:spPr>
            <a:xfrm>
              <a:off x="913987" y="2387390"/>
              <a:ext cx="1138575" cy="215782"/>
            </a:xfrm>
            <a:prstGeom prst="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9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mT2::2xMyc::AID*</a:t>
              </a:r>
            </a:p>
          </p:txBody>
        </p: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347D3017-C364-E782-ABF0-98D185B5AEFA}"/>
                </a:ext>
              </a:extLst>
            </p:cNvPr>
            <p:cNvCxnSpPr>
              <a:cxnSpLocks/>
            </p:cNvCxnSpPr>
            <p:nvPr/>
          </p:nvCxnSpPr>
          <p:spPr>
            <a:xfrm>
              <a:off x="902982" y="1630210"/>
              <a:ext cx="581835" cy="15849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52741211-CB26-5B9C-9E2F-3C75C71EF61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84817" y="1630210"/>
              <a:ext cx="564660" cy="15948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57207871-D70C-6DE9-196B-1C07751F450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81731" y="1790969"/>
              <a:ext cx="0" cy="1358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3E89071B-D92B-4655-AD41-F9BBC02FD4F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13986" y="2193276"/>
              <a:ext cx="570830" cy="1946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33508705-9294-EA2C-DEF1-383B6EF93E55}"/>
                </a:ext>
              </a:extLst>
            </p:cNvPr>
            <p:cNvCxnSpPr>
              <a:cxnSpLocks/>
            </p:cNvCxnSpPr>
            <p:nvPr/>
          </p:nvCxnSpPr>
          <p:spPr>
            <a:xfrm>
              <a:off x="1481731" y="2193275"/>
              <a:ext cx="570831" cy="19259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B026B92F-1E67-E4A9-9C8B-E39ECA7F22F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81731" y="2057428"/>
              <a:ext cx="0" cy="1358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BEDE1EA5-DA97-1DFD-0454-BF3C05A1F712}"/>
                </a:ext>
              </a:extLst>
            </p:cNvPr>
            <p:cNvSpPr/>
            <p:nvPr/>
          </p:nvSpPr>
          <p:spPr>
            <a:xfrm>
              <a:off x="906067" y="1416400"/>
              <a:ext cx="1143410" cy="215782"/>
            </a:xfrm>
            <a:prstGeom prst="rect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9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ID*::mNG::2xHA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0E634CE-9A8D-205B-EA22-01C0AA7BDFF4}"/>
                </a:ext>
              </a:extLst>
            </p:cNvPr>
            <p:cNvSpPr txBox="1"/>
            <p:nvPr/>
          </p:nvSpPr>
          <p:spPr>
            <a:xfrm>
              <a:off x="460445" y="1342049"/>
              <a:ext cx="7102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  <p:grpSp>
        <p:nvGrpSpPr>
          <p:cNvPr id="44" name="Group 43">
            <a:extLst>
              <a:ext uri="{FF2B5EF4-FFF2-40B4-BE49-F238E27FC236}">
                <a16:creationId xmlns:a16="http://schemas.microsoft.com/office/drawing/2014/main" id="{274256A0-D93A-CEF0-7226-1E70D9083C37}"/>
              </a:ext>
            </a:extLst>
          </p:cNvPr>
          <p:cNvGrpSpPr/>
          <p:nvPr/>
        </p:nvGrpSpPr>
        <p:grpSpPr>
          <a:xfrm>
            <a:off x="203585" y="1817962"/>
            <a:ext cx="4645345" cy="1314501"/>
            <a:chOff x="206204" y="2325882"/>
            <a:chExt cx="4645345" cy="1314501"/>
          </a:xfrm>
        </p:grpSpPr>
        <p:pic>
          <p:nvPicPr>
            <p:cNvPr id="19" name="Picture 18" descr="A close up of a smoke&#10;&#10;AI-generated content may be incorrect.">
              <a:extLst>
                <a:ext uri="{FF2B5EF4-FFF2-40B4-BE49-F238E27FC236}">
                  <a16:creationId xmlns:a16="http://schemas.microsoft.com/office/drawing/2014/main" id="{AEAA2AC1-8ED4-50CB-C2A6-5632ED5FD51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 rot="16200000">
              <a:off x="3585455" y="2034085"/>
              <a:ext cx="703387" cy="1828800"/>
            </a:xfrm>
            <a:prstGeom prst="rect">
              <a:avLst/>
            </a:prstGeom>
          </p:spPr>
        </p:pic>
        <p:pic>
          <p:nvPicPr>
            <p:cNvPr id="21" name="Picture 20" descr="A close-up of a curved object&#10;&#10;AI-generated content may be incorrect.">
              <a:extLst>
                <a:ext uri="{FF2B5EF4-FFF2-40B4-BE49-F238E27FC236}">
                  <a16:creationId xmlns:a16="http://schemas.microsoft.com/office/drawing/2014/main" id="{9E4C9957-CC7F-EF40-AAEA-BCAEF726EF5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 rot="16200000">
              <a:off x="1700208" y="2034085"/>
              <a:ext cx="703387" cy="1828800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A37E115C-E922-D9BD-54D1-5CC1589B0076}"/>
                </a:ext>
              </a:extLst>
            </p:cNvPr>
            <p:cNvSpPr txBox="1"/>
            <p:nvPr/>
          </p:nvSpPr>
          <p:spPr>
            <a:xfrm>
              <a:off x="587395" y="3378617"/>
              <a:ext cx="12863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enotype: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576E0C39-A6DF-A8B7-A0FF-1736F6675642}"/>
                </a:ext>
              </a:extLst>
            </p:cNvPr>
            <p:cNvSpPr txBox="1"/>
            <p:nvPr/>
          </p:nvSpPr>
          <p:spPr>
            <a:xfrm>
              <a:off x="1137501" y="3394162"/>
              <a:ext cx="3714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omatic TIR1 + AID*::MIG-15 + YAP-1::mNG </a:t>
              </a:r>
            </a:p>
          </p:txBody>
        </p: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617DA5F9-826E-44F4-10BA-0F8C8DEC6AB6}"/>
                </a:ext>
              </a:extLst>
            </p:cNvPr>
            <p:cNvCxnSpPr>
              <a:cxnSpLocks/>
            </p:cNvCxnSpPr>
            <p:nvPr/>
          </p:nvCxnSpPr>
          <p:spPr>
            <a:xfrm>
              <a:off x="1137501" y="3364080"/>
              <a:ext cx="371404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DB529A08-A598-1A15-0FE9-A96D357665F1}"/>
                </a:ext>
              </a:extLst>
            </p:cNvPr>
            <p:cNvSpPr txBox="1"/>
            <p:nvPr/>
          </p:nvSpPr>
          <p:spPr>
            <a:xfrm>
              <a:off x="395058" y="2346466"/>
              <a:ext cx="12863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reatment: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35D12AB-EBF8-EFBD-80BB-3F73600EE0C5}"/>
                </a:ext>
              </a:extLst>
            </p:cNvPr>
            <p:cNvSpPr txBox="1"/>
            <p:nvPr/>
          </p:nvSpPr>
          <p:spPr>
            <a:xfrm>
              <a:off x="1137502" y="2344049"/>
              <a:ext cx="18288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5EE2668B-FFDA-D5B2-5E92-EFB128F0FCF8}"/>
                </a:ext>
              </a:extLst>
            </p:cNvPr>
            <p:cNvSpPr txBox="1"/>
            <p:nvPr/>
          </p:nvSpPr>
          <p:spPr>
            <a:xfrm>
              <a:off x="3022749" y="2342123"/>
              <a:ext cx="18288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uxin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F99E01E4-D1EF-27EC-4BDD-4AE2745C43BA}"/>
                </a:ext>
              </a:extLst>
            </p:cNvPr>
            <p:cNvSpPr txBox="1"/>
            <p:nvPr/>
          </p:nvSpPr>
          <p:spPr>
            <a:xfrm>
              <a:off x="206204" y="2325882"/>
              <a:ext cx="7102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C88948C5-A148-7438-8675-3FCB85DF3735}"/>
              </a:ext>
            </a:extLst>
          </p:cNvPr>
          <p:cNvSpPr txBox="1"/>
          <p:nvPr/>
        </p:nvSpPr>
        <p:spPr>
          <a:xfrm>
            <a:off x="1537345" y="4629600"/>
            <a:ext cx="54087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0CEF0F2-400F-C9C2-0D45-CBA320E02B8E}"/>
              </a:ext>
            </a:extLst>
          </p:cNvPr>
          <p:cNvSpPr txBox="1"/>
          <p:nvPr/>
        </p:nvSpPr>
        <p:spPr>
          <a:xfrm>
            <a:off x="2059440" y="4629600"/>
            <a:ext cx="54087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3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6E5FAA76-6E0F-6F0D-E498-A6D13F2DB7A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3069" t="7814" r="31238" b="76944"/>
          <a:stretch>
            <a:fillRect/>
          </a:stretch>
        </p:blipFill>
        <p:spPr>
          <a:xfrm>
            <a:off x="2578691" y="3351533"/>
            <a:ext cx="390411" cy="723083"/>
          </a:xfrm>
          <a:prstGeom prst="rect">
            <a:avLst/>
          </a:prstGeom>
        </p:spPr>
      </p:pic>
      <p:sp>
        <p:nvSpPr>
          <p:cNvPr id="34" name="Left Bracket 33">
            <a:extLst>
              <a:ext uri="{FF2B5EF4-FFF2-40B4-BE49-F238E27FC236}">
                <a16:creationId xmlns:a16="http://schemas.microsoft.com/office/drawing/2014/main" id="{4689BE41-6E73-3ADF-F1FF-A90BC9D217C0}"/>
              </a:ext>
            </a:extLst>
          </p:cNvPr>
          <p:cNvSpPr/>
          <p:nvPr/>
        </p:nvSpPr>
        <p:spPr>
          <a:xfrm rot="5400000">
            <a:off x="1998165" y="3130338"/>
            <a:ext cx="45719" cy="523602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BBF16FE-EEDC-1DC4-762D-146004EBCDCB}"/>
              </a:ext>
            </a:extLst>
          </p:cNvPr>
          <p:cNvSpPr txBox="1"/>
          <p:nvPr/>
        </p:nvSpPr>
        <p:spPr>
          <a:xfrm>
            <a:off x="1789075" y="3195356"/>
            <a:ext cx="8931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5C7BACB-904C-8BF6-7033-0096E24C76C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8661" t="10072" r="41098" b="48312"/>
          <a:stretch>
            <a:fillRect/>
          </a:stretch>
        </p:blipFill>
        <p:spPr>
          <a:xfrm>
            <a:off x="1320338" y="3346955"/>
            <a:ext cx="1267301" cy="178205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06C1232-B39F-FA84-80B9-1C21953224FE}"/>
              </a:ext>
            </a:extLst>
          </p:cNvPr>
          <p:cNvSpPr txBox="1"/>
          <p:nvPr/>
        </p:nvSpPr>
        <p:spPr>
          <a:xfrm rot="16200000">
            <a:off x="231126" y="4138026"/>
            <a:ext cx="153139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% animal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2E60BAF-05A6-B7ED-E4B5-CD85DB789F42}"/>
              </a:ext>
            </a:extLst>
          </p:cNvPr>
          <p:cNvSpPr txBox="1"/>
          <p:nvPr/>
        </p:nvSpPr>
        <p:spPr>
          <a:xfrm>
            <a:off x="1547362" y="4847846"/>
            <a:ext cx="7383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EDF1CF4-3358-5770-CF7C-3436A13B27AA}"/>
              </a:ext>
            </a:extLst>
          </p:cNvPr>
          <p:cNvSpPr txBox="1"/>
          <p:nvPr/>
        </p:nvSpPr>
        <p:spPr>
          <a:xfrm>
            <a:off x="2067501" y="4846175"/>
            <a:ext cx="7383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3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C13FB31-143E-802C-4918-F4A2BEC7771F}"/>
              </a:ext>
            </a:extLst>
          </p:cNvPr>
          <p:cNvSpPr txBox="1"/>
          <p:nvPr/>
        </p:nvSpPr>
        <p:spPr>
          <a:xfrm>
            <a:off x="203584" y="3237527"/>
            <a:ext cx="39112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B09D036-38DC-70AF-E165-01856C53C04F}"/>
              </a:ext>
            </a:extLst>
          </p:cNvPr>
          <p:cNvSpPr txBox="1"/>
          <p:nvPr/>
        </p:nvSpPr>
        <p:spPr>
          <a:xfrm>
            <a:off x="2883505" y="3449448"/>
            <a:ext cx="15355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ild-type 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1D74A917-4A35-F0BE-A50E-5B639262AC8F}"/>
              </a:ext>
            </a:extLst>
          </p:cNvPr>
          <p:cNvSpPr txBox="1"/>
          <p:nvPr/>
        </p:nvSpPr>
        <p:spPr>
          <a:xfrm>
            <a:off x="2883505" y="3695669"/>
            <a:ext cx="15355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Vul 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3318A46-5798-CCB8-A634-6283EF6F3A3A}"/>
              </a:ext>
            </a:extLst>
          </p:cNvPr>
          <p:cNvSpPr txBox="1"/>
          <p:nvPr/>
        </p:nvSpPr>
        <p:spPr>
          <a:xfrm>
            <a:off x="1151614" y="4934458"/>
            <a:ext cx="4867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15DBA9D-5FC8-E857-0229-9F8FCB186185}"/>
              </a:ext>
            </a:extLst>
          </p:cNvPr>
          <p:cNvSpPr txBox="1"/>
          <p:nvPr/>
        </p:nvSpPr>
        <p:spPr>
          <a:xfrm>
            <a:off x="1086301" y="4553965"/>
            <a:ext cx="4867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9198127F-D1FB-19C6-7832-80460EFBCFFB}"/>
              </a:ext>
            </a:extLst>
          </p:cNvPr>
          <p:cNvSpPr txBox="1"/>
          <p:nvPr/>
        </p:nvSpPr>
        <p:spPr>
          <a:xfrm>
            <a:off x="1086300" y="4159431"/>
            <a:ext cx="4867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75EA860-61A8-8201-FD16-7EDD840439DF}"/>
              </a:ext>
            </a:extLst>
          </p:cNvPr>
          <p:cNvSpPr txBox="1"/>
          <p:nvPr/>
        </p:nvSpPr>
        <p:spPr>
          <a:xfrm>
            <a:off x="1086300" y="3762148"/>
            <a:ext cx="4867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7CC23D4B-5429-6F2C-5130-F544AF998CC5}"/>
              </a:ext>
            </a:extLst>
          </p:cNvPr>
          <p:cNvSpPr txBox="1"/>
          <p:nvPr/>
        </p:nvSpPr>
        <p:spPr>
          <a:xfrm>
            <a:off x="1020304" y="3363525"/>
            <a:ext cx="4867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grpSp>
        <p:nvGrpSpPr>
          <p:cNvPr id="54" name="Group 53">
            <a:extLst>
              <a:ext uri="{FF2B5EF4-FFF2-40B4-BE49-F238E27FC236}">
                <a16:creationId xmlns:a16="http://schemas.microsoft.com/office/drawing/2014/main" id="{8F5EE8DB-26E1-B63F-685B-6D9E739825FD}"/>
              </a:ext>
            </a:extLst>
          </p:cNvPr>
          <p:cNvGrpSpPr/>
          <p:nvPr/>
        </p:nvGrpSpPr>
        <p:grpSpPr>
          <a:xfrm>
            <a:off x="295207" y="5144765"/>
            <a:ext cx="3482809" cy="485874"/>
            <a:chOff x="295207" y="5144765"/>
            <a:chExt cx="3482809" cy="485874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FB116F2-E8DB-95E3-9D7C-9264C76C0253}"/>
                </a:ext>
              </a:extLst>
            </p:cNvPr>
            <p:cNvSpPr txBox="1"/>
            <p:nvPr/>
          </p:nvSpPr>
          <p:spPr>
            <a:xfrm>
              <a:off x="295207" y="5384418"/>
              <a:ext cx="12863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enotype: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BD32722E-4A95-E2B1-AF58-F03646E4BB2A}"/>
                </a:ext>
              </a:extLst>
            </p:cNvPr>
            <p:cNvSpPr txBox="1"/>
            <p:nvPr/>
          </p:nvSpPr>
          <p:spPr>
            <a:xfrm>
              <a:off x="839415" y="5384417"/>
              <a:ext cx="29386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omatic TIR1 + AID*::MIG-15 + YAP-1::mNG 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7732E106-58FA-4803-0055-652D316E5F56}"/>
                </a:ext>
              </a:extLst>
            </p:cNvPr>
            <p:cNvSpPr txBox="1"/>
            <p:nvPr/>
          </p:nvSpPr>
          <p:spPr>
            <a:xfrm>
              <a:off x="338478" y="5151333"/>
              <a:ext cx="34395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reatment:</a:t>
              </a:r>
            </a:p>
          </p:txBody>
        </p: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48B2C7AB-ED58-538D-A7AD-FF2AAF051F7A}"/>
                </a:ext>
              </a:extLst>
            </p:cNvPr>
            <p:cNvCxnSpPr>
              <a:cxnSpLocks/>
            </p:cNvCxnSpPr>
            <p:nvPr/>
          </p:nvCxnSpPr>
          <p:spPr>
            <a:xfrm>
              <a:off x="1320339" y="5376209"/>
              <a:ext cx="126730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45FD8A36-C93C-DEF5-C1D8-F7DBC27F0B8A}"/>
                </a:ext>
              </a:extLst>
            </p:cNvPr>
            <p:cNvSpPr txBox="1"/>
            <p:nvPr/>
          </p:nvSpPr>
          <p:spPr>
            <a:xfrm>
              <a:off x="1471136" y="5144765"/>
              <a:ext cx="5787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37E258CE-0136-389C-B158-F55FBC62854F}"/>
                </a:ext>
              </a:extLst>
            </p:cNvPr>
            <p:cNvSpPr txBox="1"/>
            <p:nvPr/>
          </p:nvSpPr>
          <p:spPr>
            <a:xfrm>
              <a:off x="2037390" y="5144765"/>
              <a:ext cx="5787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uxin</a:t>
              </a:r>
            </a:p>
          </p:txBody>
        </p:sp>
      </p:grpSp>
      <p:sp>
        <p:nvSpPr>
          <p:cNvPr id="48" name="TextBox 47">
            <a:extLst>
              <a:ext uri="{FF2B5EF4-FFF2-40B4-BE49-F238E27FC236}">
                <a16:creationId xmlns:a16="http://schemas.microsoft.com/office/drawing/2014/main" id="{C4088F1B-2820-7332-5E57-13431407D602}"/>
              </a:ext>
            </a:extLst>
          </p:cNvPr>
          <p:cNvSpPr txBox="1"/>
          <p:nvPr/>
        </p:nvSpPr>
        <p:spPr>
          <a:xfrm rot="16200000">
            <a:off x="81397" y="6530499"/>
            <a:ext cx="16057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atio YAP-1 fluorescence intensity in nucleus/cytoplasm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F0A9C7A-139F-8733-424D-150BFD8AEF8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5425" t="15115" r="36975" b="43563"/>
          <a:stretch>
            <a:fillRect/>
          </a:stretch>
        </p:blipFill>
        <p:spPr>
          <a:xfrm>
            <a:off x="1222130" y="5955461"/>
            <a:ext cx="1051446" cy="1593960"/>
          </a:xfrm>
          <a:prstGeom prst="rect">
            <a:avLst/>
          </a:prstGeom>
        </p:spPr>
      </p:pic>
      <p:sp>
        <p:nvSpPr>
          <p:cNvPr id="56" name="TextBox 55">
            <a:extLst>
              <a:ext uri="{FF2B5EF4-FFF2-40B4-BE49-F238E27FC236}">
                <a16:creationId xmlns:a16="http://schemas.microsoft.com/office/drawing/2014/main" id="{9CE1E99A-F4DA-0342-3F63-1F3474711DEB}"/>
              </a:ext>
            </a:extLst>
          </p:cNvPr>
          <p:cNvSpPr txBox="1"/>
          <p:nvPr/>
        </p:nvSpPr>
        <p:spPr>
          <a:xfrm>
            <a:off x="222416" y="7739988"/>
            <a:ext cx="8870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enotype: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DBA8CA2F-8E57-F0A4-5783-9E2CA77422D4}"/>
              </a:ext>
            </a:extLst>
          </p:cNvPr>
          <p:cNvSpPr txBox="1"/>
          <p:nvPr/>
        </p:nvSpPr>
        <p:spPr>
          <a:xfrm>
            <a:off x="849033" y="7738563"/>
            <a:ext cx="18854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omatic TIR1 + AID*::MIG-15 + YAP-1::mNG 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F56E7ED9-F7B6-66B9-D5F9-3DC2CD119353}"/>
              </a:ext>
            </a:extLst>
          </p:cNvPr>
          <p:cNvSpPr txBox="1"/>
          <p:nvPr/>
        </p:nvSpPr>
        <p:spPr>
          <a:xfrm>
            <a:off x="202815" y="7493767"/>
            <a:ext cx="9162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reatment: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5681F5AD-A5FE-4256-3FDD-E3F7468A9D72}"/>
              </a:ext>
            </a:extLst>
          </p:cNvPr>
          <p:cNvSpPr txBox="1"/>
          <p:nvPr/>
        </p:nvSpPr>
        <p:spPr>
          <a:xfrm>
            <a:off x="1263736" y="7478812"/>
            <a:ext cx="5787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84762F80-9F7E-884E-79AF-9B007734F730}"/>
              </a:ext>
            </a:extLst>
          </p:cNvPr>
          <p:cNvSpPr txBox="1"/>
          <p:nvPr/>
        </p:nvSpPr>
        <p:spPr>
          <a:xfrm>
            <a:off x="1758995" y="7478812"/>
            <a:ext cx="6769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uxin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20B7614A-E778-3CFC-96B9-C3351ECE9D59}"/>
              </a:ext>
            </a:extLst>
          </p:cNvPr>
          <p:cNvSpPr txBox="1"/>
          <p:nvPr/>
        </p:nvSpPr>
        <p:spPr>
          <a:xfrm>
            <a:off x="1081169" y="7364812"/>
            <a:ext cx="23906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7DACAED8-76CA-8FA7-48BC-EBF9CFECA1D6}"/>
              </a:ext>
            </a:extLst>
          </p:cNvPr>
          <p:cNvSpPr txBox="1"/>
          <p:nvPr/>
        </p:nvSpPr>
        <p:spPr>
          <a:xfrm>
            <a:off x="1005557" y="7078637"/>
            <a:ext cx="50191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745F9BD9-CB2A-0028-0A95-6E06E382EBE3}"/>
              </a:ext>
            </a:extLst>
          </p:cNvPr>
          <p:cNvSpPr txBox="1"/>
          <p:nvPr/>
        </p:nvSpPr>
        <p:spPr>
          <a:xfrm>
            <a:off x="1078069" y="6794729"/>
            <a:ext cx="2590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B7E4AFAA-603E-5C0F-976C-616856C3A16C}"/>
              </a:ext>
            </a:extLst>
          </p:cNvPr>
          <p:cNvSpPr txBox="1"/>
          <p:nvPr/>
        </p:nvSpPr>
        <p:spPr>
          <a:xfrm>
            <a:off x="1012646" y="6499617"/>
            <a:ext cx="44476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780D9579-A133-AC37-3353-168713015A4C}"/>
              </a:ext>
            </a:extLst>
          </p:cNvPr>
          <p:cNvSpPr txBox="1"/>
          <p:nvPr/>
        </p:nvSpPr>
        <p:spPr>
          <a:xfrm>
            <a:off x="1086967" y="6206853"/>
            <a:ext cx="2590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9146CB81-82B8-0912-F3A4-8CDCA0CE4A19}"/>
              </a:ext>
            </a:extLst>
          </p:cNvPr>
          <p:cNvSpPr txBox="1"/>
          <p:nvPr/>
        </p:nvSpPr>
        <p:spPr>
          <a:xfrm>
            <a:off x="1020667" y="5928477"/>
            <a:ext cx="55494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67B2EBB3-EBE8-1509-F1BB-22B4912F9840}"/>
              </a:ext>
            </a:extLst>
          </p:cNvPr>
          <p:cNvSpPr txBox="1"/>
          <p:nvPr/>
        </p:nvSpPr>
        <p:spPr>
          <a:xfrm>
            <a:off x="203584" y="5758300"/>
            <a:ext cx="3019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71" name="Picture 70">
            <a:extLst>
              <a:ext uri="{FF2B5EF4-FFF2-40B4-BE49-F238E27FC236}">
                <a16:creationId xmlns:a16="http://schemas.microsoft.com/office/drawing/2014/main" id="{B098104D-BC89-C016-17C5-B80F42F80767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6987" t="13895" r="34930" b="48292"/>
          <a:stretch>
            <a:fillRect/>
          </a:stretch>
        </p:blipFill>
        <p:spPr>
          <a:xfrm>
            <a:off x="3662229" y="5921976"/>
            <a:ext cx="1136073" cy="1595408"/>
          </a:xfrm>
          <a:prstGeom prst="rect">
            <a:avLst/>
          </a:prstGeom>
        </p:spPr>
      </p:pic>
      <p:sp>
        <p:nvSpPr>
          <p:cNvPr id="72" name="TextBox 71">
            <a:extLst>
              <a:ext uri="{FF2B5EF4-FFF2-40B4-BE49-F238E27FC236}">
                <a16:creationId xmlns:a16="http://schemas.microsoft.com/office/drawing/2014/main" id="{6D515D31-5C74-FDA3-DEF7-C0950F18C002}"/>
              </a:ext>
            </a:extLst>
          </p:cNvPr>
          <p:cNvSpPr txBox="1"/>
          <p:nvPr/>
        </p:nvSpPr>
        <p:spPr>
          <a:xfrm>
            <a:off x="3512639" y="7333324"/>
            <a:ext cx="23906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A250496D-87FD-5E52-1CF1-DAD688871CF3}"/>
              </a:ext>
            </a:extLst>
          </p:cNvPr>
          <p:cNvSpPr txBox="1"/>
          <p:nvPr/>
        </p:nvSpPr>
        <p:spPr>
          <a:xfrm>
            <a:off x="3512639" y="6978726"/>
            <a:ext cx="2590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D2DFB38F-5FF2-BCCA-D680-510CF02B7F43}"/>
              </a:ext>
            </a:extLst>
          </p:cNvPr>
          <p:cNvSpPr txBox="1"/>
          <p:nvPr/>
        </p:nvSpPr>
        <p:spPr>
          <a:xfrm>
            <a:off x="3507807" y="6610250"/>
            <a:ext cx="2590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E7CF5A87-1BF4-BC25-D1C7-A50933A6F1E3}"/>
              </a:ext>
            </a:extLst>
          </p:cNvPr>
          <p:cNvSpPr txBox="1"/>
          <p:nvPr/>
        </p:nvSpPr>
        <p:spPr>
          <a:xfrm>
            <a:off x="3509664" y="6252834"/>
            <a:ext cx="2590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2A90BF44-B575-2DE7-A7E0-07B67634A907}"/>
              </a:ext>
            </a:extLst>
          </p:cNvPr>
          <p:cNvSpPr txBox="1"/>
          <p:nvPr/>
        </p:nvSpPr>
        <p:spPr>
          <a:xfrm>
            <a:off x="3496598" y="5889282"/>
            <a:ext cx="2590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1B27848A-79AE-7143-D5A7-C47053DAE04A}"/>
              </a:ext>
            </a:extLst>
          </p:cNvPr>
          <p:cNvSpPr txBox="1"/>
          <p:nvPr/>
        </p:nvSpPr>
        <p:spPr>
          <a:xfrm rot="16200000">
            <a:off x="2569934" y="6544738"/>
            <a:ext cx="15954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atio YAP-1 fluorescence intensity in nucleus/cytoplasm 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FEF92A72-270E-08B4-645A-FE8BA0B11937}"/>
              </a:ext>
            </a:extLst>
          </p:cNvPr>
          <p:cNvSpPr txBox="1"/>
          <p:nvPr/>
        </p:nvSpPr>
        <p:spPr>
          <a:xfrm>
            <a:off x="3674739" y="7476023"/>
            <a:ext cx="5787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EB81B5F7-8AD3-16E9-4083-2B63D87EE783}"/>
              </a:ext>
            </a:extLst>
          </p:cNvPr>
          <p:cNvSpPr txBox="1"/>
          <p:nvPr/>
        </p:nvSpPr>
        <p:spPr>
          <a:xfrm>
            <a:off x="4172240" y="7468002"/>
            <a:ext cx="11360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uxin</a:t>
            </a:r>
          </a:p>
        </p:txBody>
      </p: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8BDF5213-182D-C2AB-3F41-259F3647232B}"/>
              </a:ext>
            </a:extLst>
          </p:cNvPr>
          <p:cNvCxnSpPr>
            <a:cxnSpLocks/>
          </p:cNvCxnSpPr>
          <p:nvPr/>
        </p:nvCxnSpPr>
        <p:spPr>
          <a:xfrm flipV="1">
            <a:off x="3473114" y="7717127"/>
            <a:ext cx="1507958" cy="49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04BD7275-AE7C-CF03-27E4-F203B2DBDDC0}"/>
              </a:ext>
            </a:extLst>
          </p:cNvPr>
          <p:cNvSpPr txBox="1"/>
          <p:nvPr/>
        </p:nvSpPr>
        <p:spPr>
          <a:xfrm>
            <a:off x="2781950" y="7714368"/>
            <a:ext cx="30309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omatic TIR1 + AID*::MIG-15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△cst-1/2(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+ YAP-1::mNG 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4C856098-9DD5-B011-86E6-BE42926F065C}"/>
              </a:ext>
            </a:extLst>
          </p:cNvPr>
          <p:cNvSpPr txBox="1"/>
          <p:nvPr/>
        </p:nvSpPr>
        <p:spPr>
          <a:xfrm>
            <a:off x="2841656" y="5717379"/>
            <a:ext cx="276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2B8982B7-C8B0-6728-8108-E41469B25415}"/>
              </a:ext>
            </a:extLst>
          </p:cNvPr>
          <p:cNvSpPr txBox="1"/>
          <p:nvPr/>
        </p:nvSpPr>
        <p:spPr>
          <a:xfrm>
            <a:off x="4046662" y="6012878"/>
            <a:ext cx="5014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94" name="Left Bracket 93">
            <a:extLst>
              <a:ext uri="{FF2B5EF4-FFF2-40B4-BE49-F238E27FC236}">
                <a16:creationId xmlns:a16="http://schemas.microsoft.com/office/drawing/2014/main" id="{3822A682-E974-21FD-FD2B-F8B2380B073C}"/>
              </a:ext>
            </a:extLst>
          </p:cNvPr>
          <p:cNvSpPr/>
          <p:nvPr/>
        </p:nvSpPr>
        <p:spPr>
          <a:xfrm rot="5400000">
            <a:off x="4151535" y="6013381"/>
            <a:ext cx="45719" cy="362069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FCEAD4FC-8F5B-3FA8-A835-1B1EF1618E4F}"/>
              </a:ext>
            </a:extLst>
          </p:cNvPr>
          <p:cNvCxnSpPr>
            <a:cxnSpLocks/>
          </p:cNvCxnSpPr>
          <p:nvPr/>
        </p:nvCxnSpPr>
        <p:spPr>
          <a:xfrm flipV="1">
            <a:off x="1019603" y="7717127"/>
            <a:ext cx="1507958" cy="49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TextBox 100">
            <a:extLst>
              <a:ext uri="{FF2B5EF4-FFF2-40B4-BE49-F238E27FC236}">
                <a16:creationId xmlns:a16="http://schemas.microsoft.com/office/drawing/2014/main" id="{E0049E79-7671-66DA-3083-657ACB57E08B}"/>
              </a:ext>
            </a:extLst>
          </p:cNvPr>
          <p:cNvSpPr txBox="1"/>
          <p:nvPr/>
        </p:nvSpPr>
        <p:spPr>
          <a:xfrm>
            <a:off x="1646872" y="5973935"/>
            <a:ext cx="5014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102" name="Left Bracket 101">
            <a:extLst>
              <a:ext uri="{FF2B5EF4-FFF2-40B4-BE49-F238E27FC236}">
                <a16:creationId xmlns:a16="http://schemas.microsoft.com/office/drawing/2014/main" id="{11868F62-A366-A3F6-0954-6F052FC99E66}"/>
              </a:ext>
            </a:extLst>
          </p:cNvPr>
          <p:cNvSpPr/>
          <p:nvPr/>
        </p:nvSpPr>
        <p:spPr>
          <a:xfrm rot="5400000">
            <a:off x="1755504" y="5972195"/>
            <a:ext cx="45719" cy="362069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440872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44</TotalTime>
  <Words>127</Words>
  <Application>Microsoft Macintosh PowerPoint</Application>
  <PresentationFormat>Letter Paper (8.5x11 in)</PresentationFormat>
  <Paragraphs>5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ynh, Linh</dc:creator>
  <cp:lastModifiedBy>Microsoft Office User</cp:lastModifiedBy>
  <cp:revision>436</cp:revision>
  <cp:lastPrinted>2025-12-30T16:59:56Z</cp:lastPrinted>
  <dcterms:created xsi:type="dcterms:W3CDTF">2025-01-17T22:21:34Z</dcterms:created>
  <dcterms:modified xsi:type="dcterms:W3CDTF">2026-02-21T01:36:37Z</dcterms:modified>
</cp:coreProperties>
</file>